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96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17" d="100"/>
          <a:sy n="117" d="100"/>
        </p:scale>
        <p:origin x="1234" y="-343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828795-4959-4806-AABA-DC6F681C3BAA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A9BD19-FFBF-459D-A6C0-8AF0C184A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458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1pPr>
    <a:lvl2pPr marL="457118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2pPr>
    <a:lvl3pPr marL="914236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3pPr>
    <a:lvl4pPr marL="1371355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4pPr>
    <a:lvl5pPr marL="1828473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5pPr>
    <a:lvl6pPr marL="2285591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6pPr>
    <a:lvl7pPr marL="2742709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7pPr>
    <a:lvl8pPr marL="3199828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8pPr>
    <a:lvl9pPr marL="3656945" algn="l" defTabSz="914236" rtl="0" eaLnBrk="1" latinLnBrk="0" hangingPunct="1">
      <a:defRPr sz="120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268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523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760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564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219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73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039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741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76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595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12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1C9DD-D960-4A0F-B6C2-75DD199C6616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67A7-7742-46AF-BEE9-942E9266A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035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1A1DD61-44F7-4B8A-9C7D-650044A864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316" y="524017"/>
            <a:ext cx="6609684" cy="184824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D9E2F17-4368-449A-AF67-BBA1A9B8AA8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316" y="3001107"/>
            <a:ext cx="6609684" cy="184824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B25ED22-3672-40AC-9814-AAC45C8F397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314" y="5478197"/>
            <a:ext cx="6609685" cy="18482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6ABAA2E-4E87-4E35-91D8-B1E78EB31945}"/>
              </a:ext>
            </a:extLst>
          </p:cNvPr>
          <p:cNvSpPr txBox="1"/>
          <p:nvPr/>
        </p:nvSpPr>
        <p:spPr>
          <a:xfrm>
            <a:off x="0" y="7778339"/>
            <a:ext cx="68579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</a:rPr>
              <a:t>Figure S1: </a:t>
            </a:r>
            <a:r>
              <a:rPr lang="en-US" sz="1400" dirty="0">
                <a:latin typeface="Palatino Linotype" panose="02040502050505030304" pitchFamily="18" charset="0"/>
              </a:rPr>
              <a:t>DESI-MSI spectra obtained from (a) skin, (b) epithelium of the vermilion and (c) the underlying tissue of the vermilion of subject 1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0670296-4A70-496D-B3A7-A2265204FC90}"/>
              </a:ext>
            </a:extLst>
          </p:cNvPr>
          <p:cNvSpPr txBox="1"/>
          <p:nvPr/>
        </p:nvSpPr>
        <p:spPr>
          <a:xfrm>
            <a:off x="5564037" y="524017"/>
            <a:ext cx="603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91B6711-6ED0-4768-8707-9FAA9DA34384}"/>
              </a:ext>
            </a:extLst>
          </p:cNvPr>
          <p:cNvSpPr txBox="1"/>
          <p:nvPr/>
        </p:nvSpPr>
        <p:spPr>
          <a:xfrm>
            <a:off x="5650301" y="3011762"/>
            <a:ext cx="603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36CBFDA-3F57-47A6-8111-11F4D22D3FC8}"/>
              </a:ext>
            </a:extLst>
          </p:cNvPr>
          <p:cNvSpPr txBox="1"/>
          <p:nvPr/>
        </p:nvSpPr>
        <p:spPr>
          <a:xfrm>
            <a:off x="5564037" y="5478197"/>
            <a:ext cx="603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(c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3D1814-8BFB-4B36-A90C-E76C5ED12FC4}"/>
              </a:ext>
            </a:extLst>
          </p:cNvPr>
          <p:cNvSpPr txBox="1"/>
          <p:nvPr/>
        </p:nvSpPr>
        <p:spPr>
          <a:xfrm>
            <a:off x="6041566" y="2028762"/>
            <a:ext cx="603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  <a:cs typeface="Arial" panose="020B0604020202020204" pitchFamily="34" charset="0"/>
              </a:rPr>
              <a:t>327.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36697E4-6579-48D7-9DAA-BFCCDEF172D9}"/>
              </a:ext>
            </a:extLst>
          </p:cNvPr>
          <p:cNvSpPr txBox="1"/>
          <p:nvPr/>
        </p:nvSpPr>
        <p:spPr>
          <a:xfrm rot="16200000">
            <a:off x="-359848" y="3897426"/>
            <a:ext cx="121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Palatino Linotype" panose="02040502050505030304" pitchFamily="18" charset="0"/>
              </a:rPr>
              <a:t>Intensit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CE3CC9B-0CC7-4AA3-B997-4DA72506E9B4}"/>
              </a:ext>
            </a:extLst>
          </p:cNvPr>
          <p:cNvSpPr txBox="1"/>
          <p:nvPr/>
        </p:nvSpPr>
        <p:spPr>
          <a:xfrm rot="16200000">
            <a:off x="-243169" y="1398780"/>
            <a:ext cx="982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Palatino Linotype" panose="02040502050505030304" pitchFamily="18" charset="0"/>
              </a:rPr>
              <a:t>Intensity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9DDFF17-22AC-4DCD-A573-EC886556E042}"/>
              </a:ext>
            </a:extLst>
          </p:cNvPr>
          <p:cNvSpPr txBox="1"/>
          <p:nvPr/>
        </p:nvSpPr>
        <p:spPr>
          <a:xfrm rot="16200000">
            <a:off x="-359848" y="6374516"/>
            <a:ext cx="121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Palatino Linotype" panose="02040502050505030304" pitchFamily="18" charset="0"/>
              </a:rPr>
              <a:t>Intensity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34B9A43-6D17-4C06-BE6B-68C24AE52AA1}"/>
              </a:ext>
            </a:extLst>
          </p:cNvPr>
          <p:cNvSpPr txBox="1"/>
          <p:nvPr/>
        </p:nvSpPr>
        <p:spPr>
          <a:xfrm>
            <a:off x="6382679" y="4505588"/>
            <a:ext cx="6414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/>
              <a:t>m/z</a:t>
            </a:r>
          </a:p>
        </p:txBody>
      </p:sp>
    </p:spTree>
    <p:extLst>
      <p:ext uri="{BB962C8B-B14F-4D97-AF65-F5344CB8AC3E}">
        <p14:creationId xmlns:p14="http://schemas.microsoft.com/office/powerpoint/2010/main" val="4281138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0-04-09T10:11:46Z</dcterms:created>
  <dcterms:modified xsi:type="dcterms:W3CDTF">2020-04-17T07:07:56Z</dcterms:modified>
</cp:coreProperties>
</file>